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12115" y="669290"/>
            <a:ext cx="10515600" cy="4351338"/>
          </a:xfrm>
        </p:spPr>
        <p:txBody>
          <a:bodyPr/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S1 – AfBBX coding sequence (PowerPoint format).</a:t>
            </a:r>
            <a:endParaRPr lang="en-US" altLang="zh-CN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The full-length coding sequence (CDS) of </a:t>
            </a:r>
            <a:r>
              <a:rPr lang="en-US" altLang="zh-CN" i="1">
                <a:latin typeface="Times New Roman" panose="02020603050405020304" pitchFamily="18" charset="0"/>
                <a:cs typeface="Times New Roman" panose="02020603050405020304" pitchFamily="18" charset="0"/>
              </a:rPr>
              <a:t>AfBBX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 was obtained from transcriptome sequencing data of Amorpha fruticosa. The CDS is 1,116 base pairs in length, encoding a protein of 371 amino acids. The sequence is provided as a PowerPoint file (SupplementaryS1.pptx), which contains the complete CDS in a clearly formatted slide. The sequence can also be requested from the corresponding author upon reasonable request.</a:t>
            </a:r>
            <a:endParaRPr lang="en-US" altLang="zh-CN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4800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</a:t>
            </a:r>
            <a:r>
              <a:rPr lang="en-US" altLang="zh-CN" sz="4800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-box</a:t>
            </a:r>
            <a:endParaRPr lang="zh-CN" altLang="en-US" sz="4800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88975" y="1426210"/>
            <a:ext cx="9920844" cy="4351338"/>
          </a:xfrm>
        </p:spPr>
        <p:txBody>
          <a:bodyPr>
            <a:normAutofit lnSpcReduction="10000"/>
          </a:bodyPr>
          <a:lstStyle/>
          <a:p>
            <a:r>
              <a:rPr lang="en-US" altLang="zh-CN" sz="1800" kern="100" dirty="0">
                <a:effectLst/>
                <a:highlight>
                  <a:srgbClr val="00FF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G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GAATCGAGAGAGGAGGCTTAAAGGGCTTTAGGAGCGGATGGAGCGTACCACCGAAGCCATGCGACACGTGCAAGCTGGCTTCGGCGGCGCTTTTCTGCCGCCCCGATTCCGCGTTCCTATGCATCGCATGTGATTCGAAGATTCACTGCGCCAACAAGCTGGCATCGCGCCACGAGCGCGTGTGGATGTGTGAGGTGTGCGAGCAGGCACCAGCAGCGGTCACGTGCAAGGCAGACGCGGCCGCTCTCTGCGTCACGTGCGACTCCGACATCCACTCGGCGAACCCCCTCGCCCGCCGCCACGAGCGTGTCCCCGTGGAGCCCTTCTTCGACTCCGCCGAGTCCATCGTGAAGGCCTCCGCCGCCTTCAGCTTCGTCGTCCCCGCCGACAACACCACCAACAACAACGGTATTGCTTCCGACACCTTCAACGCCGACGACGCTGCCTGGCTCATCCCAAACCCCAATTTCGGGTCCAAGCTCATGGATGCCCCGGACATCAAGTCCAGGGAGATGTTCTTCTCCGACATGGACCCCTTCCTCGATTTCGATTACCCAAACTCCTTCCACCACCACAGCGCCGGAAACGACAGCGTTGTCCCCGTTCAGACCAAACCCGCTCCCGCTCCCTCTCCTATTATCAATCCCCACTCCGAGGGTTGCTTCGACATCGACTTCTGCAGATCGAAGCTCTCCTCCTTCAACTACCCATCACAGTCTGTTAGCCAAAGCGTTTCGTCGTCGTCGCTTGATGTCGGAGTGGTGCCGGATGGAACCACGGTGTCGGATATGTCGTACTCTTTCGGACGGAACAGCTCCGATTCGAGCGGGATGTTGTCGGGTGGTGGCGGAGGACAAGCGACGCAGTTGTGCGGGTTGGACAGGGAAGCGAGGGTGCTGAGGTACAGGGAGAAGAGGAAGAACCGCAAGTTCGAGAAAACCATTCGATACGCTTCGCGAAAGGCTTACGCAGAAACCCGGCCCAGGATCAAGGGCCGGTTCGCCAAGCGGACCGAAATCGACTCGGACCTGGACCGGCTTTATAGCCCCGCCGCTTCTGTCCCTGGCTCTCTCATGCTGGACTCTCAGTACGGCGTCGTCCCGTCTTTT</a:t>
            </a:r>
            <a:r>
              <a:rPr lang="en-US" altLang="zh-CN" sz="1800" kern="100" dirty="0">
                <a:effectLst/>
                <a:highlight>
                  <a:srgbClr val="FF0000"/>
                </a:highlight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06</Words>
  <Application>WPS 演示</Application>
  <PresentationFormat>宽屏</PresentationFormat>
  <Paragraphs>1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WPS</vt:lpstr>
      <vt:lpstr>PowerPoint 演示文稿</vt:lpstr>
      <vt:lpstr>Af B-box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eimengwen</dc:creator>
  <cp:lastModifiedBy>红色鲱鱼</cp:lastModifiedBy>
  <cp:revision>5</cp:revision>
  <dcterms:created xsi:type="dcterms:W3CDTF">2023-08-09T12:44:00Z</dcterms:created>
  <dcterms:modified xsi:type="dcterms:W3CDTF">2026-04-02T13:31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179022BC5D914333A3B085547D2DE57F_12</vt:lpwstr>
  </property>
</Properties>
</file>